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1" r:id="rId3"/>
  </p:sldIdLst>
  <p:sldSz cx="6858000" cy="9144000" type="screen4x3"/>
  <p:notesSz cx="6858000" cy="9144000"/>
  <p:defaultTextStyle>
    <a:defPPr>
      <a:defRPr lang="fr-FR"/>
    </a:defPPr>
    <a:lvl1pPr marL="0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13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26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39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53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66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679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792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905" algn="l" defTabSz="91422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5EB6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E8B1032C-EA38-4F05-BA0D-38AFFFC7BED3}" styleName="Style léger 3 - Accentuation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13" autoAdjust="0"/>
    <p:restoredTop sz="99874" autoAdjust="0"/>
  </p:normalViewPr>
  <p:slideViewPr>
    <p:cSldViewPr>
      <p:cViewPr>
        <p:scale>
          <a:sx n="100" d="100"/>
          <a:sy n="100" d="100"/>
        </p:scale>
        <p:origin x="-4024" y="-28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A31F5-0CE8-5243-9D96-2C4EE419CA18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E6AB49-88C0-B343-8F02-16458F7C191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9558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13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26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39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53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566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679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792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905" algn="l" defTabSz="4571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6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7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9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9290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0255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3218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244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1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2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6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7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9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3968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0766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3" indent="0">
              <a:buNone/>
              <a:defRPr sz="2000" b="1"/>
            </a:lvl2pPr>
            <a:lvl3pPr marL="914226" indent="0">
              <a:buNone/>
              <a:defRPr sz="1800" b="1"/>
            </a:lvl3pPr>
            <a:lvl4pPr marL="1371339" indent="0">
              <a:buNone/>
              <a:defRPr sz="1600" b="1"/>
            </a:lvl4pPr>
            <a:lvl5pPr marL="1828453" indent="0">
              <a:buNone/>
              <a:defRPr sz="1600" b="1"/>
            </a:lvl5pPr>
            <a:lvl6pPr marL="2285566" indent="0">
              <a:buNone/>
              <a:defRPr sz="1600" b="1"/>
            </a:lvl6pPr>
            <a:lvl7pPr marL="2742679" indent="0">
              <a:buNone/>
              <a:defRPr sz="1600" b="1"/>
            </a:lvl7pPr>
            <a:lvl8pPr marL="3199792" indent="0">
              <a:buNone/>
              <a:defRPr sz="1600" b="1"/>
            </a:lvl8pPr>
            <a:lvl9pPr marL="3656905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3" indent="0">
              <a:buNone/>
              <a:defRPr sz="2000" b="1"/>
            </a:lvl2pPr>
            <a:lvl3pPr marL="914226" indent="0">
              <a:buNone/>
              <a:defRPr sz="1800" b="1"/>
            </a:lvl3pPr>
            <a:lvl4pPr marL="1371339" indent="0">
              <a:buNone/>
              <a:defRPr sz="1600" b="1"/>
            </a:lvl4pPr>
            <a:lvl5pPr marL="1828453" indent="0">
              <a:buNone/>
              <a:defRPr sz="1600" b="1"/>
            </a:lvl5pPr>
            <a:lvl6pPr marL="2285566" indent="0">
              <a:buNone/>
              <a:defRPr sz="1600" b="1"/>
            </a:lvl6pPr>
            <a:lvl7pPr marL="2742679" indent="0">
              <a:buNone/>
              <a:defRPr sz="1600" b="1"/>
            </a:lvl7pPr>
            <a:lvl8pPr marL="3199792" indent="0">
              <a:buNone/>
              <a:defRPr sz="1600" b="1"/>
            </a:lvl8pPr>
            <a:lvl9pPr marL="3656905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7188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4835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039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13" indent="0">
              <a:buNone/>
              <a:defRPr sz="1200"/>
            </a:lvl2pPr>
            <a:lvl3pPr marL="914226" indent="0">
              <a:buNone/>
              <a:defRPr sz="1000"/>
            </a:lvl3pPr>
            <a:lvl4pPr marL="1371339" indent="0">
              <a:buNone/>
              <a:defRPr sz="900"/>
            </a:lvl4pPr>
            <a:lvl5pPr marL="1828453" indent="0">
              <a:buNone/>
              <a:defRPr sz="900"/>
            </a:lvl5pPr>
            <a:lvl6pPr marL="2285566" indent="0">
              <a:buNone/>
              <a:defRPr sz="900"/>
            </a:lvl6pPr>
            <a:lvl7pPr marL="2742679" indent="0">
              <a:buNone/>
              <a:defRPr sz="900"/>
            </a:lvl7pPr>
            <a:lvl8pPr marL="3199792" indent="0">
              <a:buNone/>
              <a:defRPr sz="900"/>
            </a:lvl8pPr>
            <a:lvl9pPr marL="3656905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9583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13" indent="0">
              <a:buNone/>
              <a:defRPr sz="2800"/>
            </a:lvl2pPr>
            <a:lvl3pPr marL="914226" indent="0">
              <a:buNone/>
              <a:defRPr sz="2400"/>
            </a:lvl3pPr>
            <a:lvl4pPr marL="1371339" indent="0">
              <a:buNone/>
              <a:defRPr sz="2000"/>
            </a:lvl4pPr>
            <a:lvl5pPr marL="1828453" indent="0">
              <a:buNone/>
              <a:defRPr sz="2000"/>
            </a:lvl5pPr>
            <a:lvl6pPr marL="2285566" indent="0">
              <a:buNone/>
              <a:defRPr sz="2000"/>
            </a:lvl6pPr>
            <a:lvl7pPr marL="2742679" indent="0">
              <a:buNone/>
              <a:defRPr sz="2000"/>
            </a:lvl7pPr>
            <a:lvl8pPr marL="3199792" indent="0">
              <a:buNone/>
              <a:defRPr sz="2000"/>
            </a:lvl8pPr>
            <a:lvl9pPr marL="3656905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13" indent="0">
              <a:buNone/>
              <a:defRPr sz="1200"/>
            </a:lvl2pPr>
            <a:lvl3pPr marL="914226" indent="0">
              <a:buNone/>
              <a:defRPr sz="1000"/>
            </a:lvl3pPr>
            <a:lvl4pPr marL="1371339" indent="0">
              <a:buNone/>
              <a:defRPr sz="900"/>
            </a:lvl4pPr>
            <a:lvl5pPr marL="1828453" indent="0">
              <a:buNone/>
              <a:defRPr sz="900"/>
            </a:lvl5pPr>
            <a:lvl6pPr marL="2285566" indent="0">
              <a:buNone/>
              <a:defRPr sz="900"/>
            </a:lvl6pPr>
            <a:lvl7pPr marL="2742679" indent="0">
              <a:buNone/>
              <a:defRPr sz="900"/>
            </a:lvl7pPr>
            <a:lvl8pPr marL="3199792" indent="0">
              <a:buNone/>
              <a:defRPr sz="900"/>
            </a:lvl8pPr>
            <a:lvl9pPr marL="3656905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106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23" tIns="45711" rIns="91423" bIns="45711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23" tIns="45711" rIns="91423" bIns="45711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FB457-86DE-46A4-8323-ACB40910B360}" type="datetimeFigureOut">
              <a:rPr lang="fr-FR" smtClean="0"/>
              <a:t>15/07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23" tIns="45711" rIns="91423" bIns="45711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23" tIns="45711" rIns="91423" bIns="45711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53FDB-E797-47E9-AD55-94ACAFB77A4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79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2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5" indent="-342835" algn="l" defTabSz="914226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09" indent="-285696" algn="l" defTabSz="914226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83" indent="-228557" algn="l" defTabSz="91422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96" indent="-228557" algn="l" defTabSz="914226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09" indent="-228557" algn="l" defTabSz="914226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22" indent="-228557" algn="l" defTabSz="91422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35" indent="-228557" algn="l" defTabSz="91422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48" indent="-228557" algn="l" defTabSz="91422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62" indent="-228557" algn="l" defTabSz="91422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13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26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39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53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66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679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92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05" algn="l" defTabSz="91422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9423751"/>
              </p:ext>
            </p:extLst>
          </p:nvPr>
        </p:nvGraphicFramePr>
        <p:xfrm>
          <a:off x="476673" y="395530"/>
          <a:ext cx="5688630" cy="728753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23275"/>
                <a:gridCol w="2690971"/>
                <a:gridCol w="593596"/>
                <a:gridCol w="593596"/>
                <a:gridCol w="593596"/>
                <a:gridCol w="593596"/>
              </a:tblGrid>
              <a:tr h="26369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 rtl="0" fontAlgn="ctr"/>
                      <a:r>
                        <a:rPr lang="fr-FR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ategory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 rtl="0" fontAlgn="ctr"/>
                      <a:r>
                        <a:rPr lang="fr-FR" sz="8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 </a:t>
                      </a:r>
                      <a:r>
                        <a:rPr lang="fr-FR" sz="800" b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erms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les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emales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0630">
                <a:tc vMerge="1">
                  <a:txBody>
                    <a:bodyPr/>
                    <a:lstStyle/>
                    <a:p>
                      <a:pPr algn="ctr" rtl="0" fontAlgn="ctr"/>
                      <a:endParaRPr lang="fr-FR" sz="6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350" marR="7350" marT="735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50" marR="7350" marT="7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. of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enjamini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. of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enjamini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5489"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p-</a:t>
                      </a:r>
                      <a:r>
                        <a:rPr lang="fr-FR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gulated</a:t>
                      </a:r>
                      <a:r>
                        <a:rPr lang="fr-FR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54~inflammatory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97E-1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33</a:t>
                      </a:r>
                      <a:r>
                        <a:rPr lang="fr-FR" sz="800" u="none" strike="noStrike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063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0729~positive regulation of inflammatory respon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,29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2526~acut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flammatory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44E-0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2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2544~chronic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flammatory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45 E 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2496~response to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ipopolysaccharid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54E-0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83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9617~response to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acterium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7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,35E-08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9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8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4097~response to cytokin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81E-0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1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4612~response to tumor necrosis fact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22E-0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5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6651~lymphocyt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lifer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,94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55~immun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6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55E-07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1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5087~innate immun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47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15~apoptotic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ces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5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14E-06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5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,11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3065~positive regulation of apoptot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34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3066~negative regulation of apoptot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63E-0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6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7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3002~muscl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lifer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7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47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246~regulation of protein metabol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06E-0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1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6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25063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248~negative regulation of protein metabol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32E-04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063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247~positive regulation of protein metabol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6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73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5859~regulation of protein kinase activ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43 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76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4599~cellular </a:t>
                      </a:r>
                      <a:r>
                        <a:rPr lang="fr-FR" sz="800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o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xidative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stres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25063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5137~development of primary sexual characteristic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74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8406~gonad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evelopment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54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28687"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own-</a:t>
                      </a:r>
                      <a:r>
                        <a:rPr lang="fr-FR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gulated</a:t>
                      </a:r>
                      <a:r>
                        <a:rPr lang="fr-FR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5739~mitochondr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0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64E-05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,33E-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0198~extracellular matrix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rganiz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65E-0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2692~muscl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ifferenti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32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60537~muscle tissu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evelopment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4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65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61061~muscle structur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evelopment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25 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2383~sarcolemma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92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0315~T-tubul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20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60047~heart contrac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42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36~muscle contrac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96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8015~blood circulation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38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60048~cardiac muscle contrac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71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3292~contractil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iber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0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3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0016~myofibril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77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ø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C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0017~sarcomer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46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811~ion transport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,4 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-03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71805~potassium ion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ansmembrane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transport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,50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P</a:t>
                      </a: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</a:t>
                      </a:r>
                      <a:r>
                        <a:rPr lang="is-I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:0090279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~</a:t>
                      </a:r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egulation</a:t>
                      </a:r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f calcium ion import</a:t>
                      </a:r>
                    </a:p>
                  </a:txBody>
                  <a:tcPr marL="12700" marR="12700" marT="127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0637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928~positive regulation of calcium ion transpor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49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KEGG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no04510:Focal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dhes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42E-04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,0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40630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KEGG</a:t>
                      </a:r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no04151:PI3K-Akt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ignaling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,00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350" marR="7350" marT="7350" marB="0" anchor="ctr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2320368" y="8460432"/>
            <a:ext cx="2217264" cy="369314"/>
          </a:xfrm>
          <a:prstGeom prst="rect">
            <a:avLst/>
          </a:prstGeom>
          <a:noFill/>
        </p:spPr>
        <p:txBody>
          <a:bodyPr wrap="none" lIns="91423" tIns="45711" rIns="91423" bIns="45711" rtlCol="0">
            <a:spAutoFit/>
          </a:bodyPr>
          <a:lstStyle/>
          <a:p>
            <a:r>
              <a:rPr lang="fr-FR" dirty="0" err="1" smtClean="0"/>
              <a:t>Supplemental</a:t>
            </a:r>
            <a:r>
              <a:rPr lang="fr-FR" dirty="0" smtClean="0"/>
              <a:t> Table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112991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1712117"/>
              </p:ext>
            </p:extLst>
          </p:nvPr>
        </p:nvGraphicFramePr>
        <p:xfrm>
          <a:off x="542997" y="395539"/>
          <a:ext cx="5766323" cy="416181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96799"/>
                <a:gridCol w="2656000"/>
                <a:gridCol w="713325"/>
                <a:gridCol w="648072"/>
                <a:gridCol w="576064"/>
                <a:gridCol w="576063"/>
              </a:tblGrid>
              <a:tr h="141914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ategory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erm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l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emal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8786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. of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enjamini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. of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800" b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enjamini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591">
                <a:tc gridSpan="6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p-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gulated</a:t>
                      </a:r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b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81078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55~immun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24E-0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6651~lymphocyte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lifer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16 E-02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162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0036~actin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ytoskeleton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rganiz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9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36 E-0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7010~cytoskeleton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rganiz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54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5595~regulation of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ifferenti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18 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16310~phosphoryl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47E-04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16311~dephosphoryl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25 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60402~calcium ion transport into cytos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27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</a:p>
                  </a:txBody>
                  <a:tcPr marL="8598" marR="8598" marT="859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9">
                <a:tc gridSpan="6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own-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gulated</a:t>
                      </a:r>
                      <a:r>
                        <a:rPr lang="fr-FR" sz="800" b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b="1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86249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70887~cellular response to chemical stimulu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78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8680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54~inflammatory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spon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05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8219~cell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eath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40 E-0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15~apoptotic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ces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86E-0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9986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3065~positive regulation of apoptot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 ,00 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8283~cell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liferat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9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,88 E-0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7155~cell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dhesion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,24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06979~response to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xidative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stres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,90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78299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246~regulation of protein metabol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,45 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1885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51247~positive regulation of protein metabolic proces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,04 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33993~response to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ipid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,10 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P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O:0040008~regulation of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rowth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,38 E-02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/>
                </a:tc>
              </a:tr>
              <a:tr h="156591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b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KEGG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no04010:MAPK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ignaling</a:t>
                      </a: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fr-FR" sz="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,04 E-0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ø</a:t>
                      </a:r>
                      <a:endParaRPr lang="fr-F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598" marR="8598" marT="8598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2320368" y="8460432"/>
            <a:ext cx="2217264" cy="369314"/>
          </a:xfrm>
          <a:prstGeom prst="rect">
            <a:avLst/>
          </a:prstGeom>
          <a:noFill/>
        </p:spPr>
        <p:txBody>
          <a:bodyPr wrap="none" lIns="91423" tIns="45711" rIns="91423" bIns="45711" rtlCol="0">
            <a:spAutoFit/>
          </a:bodyPr>
          <a:lstStyle/>
          <a:p>
            <a:r>
              <a:rPr lang="fr-FR" dirty="0" err="1" smtClean="0"/>
              <a:t>Supplemental</a:t>
            </a:r>
            <a:r>
              <a:rPr lang="fr-FR" dirty="0" smtClean="0"/>
              <a:t> Table 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387241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8</TotalTime>
  <Words>946</Words>
  <Application>Microsoft Macintosh PowerPoint</Application>
  <PresentationFormat>Présentation à l'écran (4:3)</PresentationFormat>
  <Paragraphs>402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n Thi Thom</dc:creator>
  <cp:lastModifiedBy>lalevee</cp:lastModifiedBy>
  <cp:revision>261</cp:revision>
  <cp:lastPrinted>2019-04-09T13:50:35Z</cp:lastPrinted>
  <dcterms:created xsi:type="dcterms:W3CDTF">2018-02-08T13:38:38Z</dcterms:created>
  <dcterms:modified xsi:type="dcterms:W3CDTF">2019-07-15T14:07:01Z</dcterms:modified>
</cp:coreProperties>
</file>